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6" r:id="rId2"/>
    <p:sldId id="273" r:id="rId3"/>
    <p:sldId id="272" r:id="rId4"/>
    <p:sldId id="265" r:id="rId5"/>
    <p:sldId id="279" r:id="rId6"/>
    <p:sldId id="263" r:id="rId7"/>
    <p:sldId id="267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332" autoAdjust="0"/>
    <p:restoredTop sz="95669" autoAdjust="0"/>
  </p:normalViewPr>
  <p:slideViewPr>
    <p:cSldViewPr snapToGrid="0">
      <p:cViewPr varScale="1">
        <p:scale>
          <a:sx n="90" d="100"/>
          <a:sy n="90" d="100"/>
        </p:scale>
        <p:origin x="72" y="1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ishi Fukushima" userId="0760ddef824ae44c" providerId="LiveId" clId="{16C11474-64C2-4BDA-9CE0-16F24750807A}"/>
    <pc:docChg chg="undo custSel modSld">
      <pc:chgData name="Taishi Fukushima" userId="0760ddef824ae44c" providerId="LiveId" clId="{16C11474-64C2-4BDA-9CE0-16F24750807A}" dt="2025-01-12T04:07:33.716" v="101" actId="14100"/>
      <pc:docMkLst>
        <pc:docMk/>
      </pc:docMkLst>
      <pc:sldChg chg="addSp delSp modSp mod">
        <pc:chgData name="Taishi Fukushima" userId="0760ddef824ae44c" providerId="LiveId" clId="{16C11474-64C2-4BDA-9CE0-16F24750807A}" dt="2025-01-12T04:07:33.716" v="101" actId="14100"/>
        <pc:sldMkLst>
          <pc:docMk/>
          <pc:sldMk cId="2278013231" sldId="265"/>
        </pc:sldMkLst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3" creationId="{9B3F88F9-48A7-9616-9CCD-6FA513B1EE10}"/>
          </ac:spMkLst>
        </pc:spChg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4" creationId="{8F7142F6-A355-5B8F-90C2-098A7392B01C}"/>
          </ac:spMkLst>
        </pc:spChg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7" creationId="{544BDFF9-39F4-E078-3DFD-7D4D089D3C41}"/>
          </ac:spMkLst>
        </pc:spChg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11" creationId="{FB7BE666-A5E6-3121-8977-79FD3AD7E3F4}"/>
          </ac:spMkLst>
        </pc:spChg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12" creationId="{6275FC12-9187-9B1C-3AA4-42709E9E1A8A}"/>
          </ac:spMkLst>
        </pc:spChg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13" creationId="{1DF9DB3B-70CA-D1F2-3939-50D73918404A}"/>
          </ac:spMkLst>
        </pc:spChg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14" creationId="{BB68D9A5-6C8D-56B2-A945-4FFCE64FECBD}"/>
          </ac:spMkLst>
        </pc:spChg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16" creationId="{09D286C7-D61D-0579-7751-7B95E9402E55}"/>
          </ac:spMkLst>
        </pc:spChg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17" creationId="{EA589911-DA33-8DB2-DC53-B1F4DF7688B5}"/>
          </ac:spMkLst>
        </pc:spChg>
        <pc:spChg chg="mod">
          <ac:chgData name="Taishi Fukushima" userId="0760ddef824ae44c" providerId="LiveId" clId="{16C11474-64C2-4BDA-9CE0-16F24750807A}" dt="2025-01-12T04:06:57.264" v="93" actId="1076"/>
          <ac:spMkLst>
            <pc:docMk/>
            <pc:sldMk cId="2278013231" sldId="265"/>
            <ac:spMk id="18" creationId="{E69CB371-BCA6-E837-DF55-BDB35A558180}"/>
          </ac:spMkLst>
        </pc:spChg>
        <pc:picChg chg="mod ord">
          <ac:chgData name="Taishi Fukushima" userId="0760ddef824ae44c" providerId="LiveId" clId="{16C11474-64C2-4BDA-9CE0-16F24750807A}" dt="2025-01-12T04:07:08.014" v="95" actId="1076"/>
          <ac:picMkLst>
            <pc:docMk/>
            <pc:sldMk cId="2278013231" sldId="265"/>
            <ac:picMk id="20" creationId="{32AA9C9A-BF0F-6FF5-A12E-05F9E758BC5E}"/>
          </ac:picMkLst>
        </pc:picChg>
        <pc:picChg chg="mod ord">
          <ac:chgData name="Taishi Fukushima" userId="0760ddef824ae44c" providerId="LiveId" clId="{16C11474-64C2-4BDA-9CE0-16F24750807A}" dt="2025-01-12T04:07:16.692" v="97" actId="1076"/>
          <ac:picMkLst>
            <pc:docMk/>
            <pc:sldMk cId="2278013231" sldId="265"/>
            <ac:picMk id="32" creationId="{809920B7-CF6C-1185-30B2-F06039B5714A}"/>
          </ac:picMkLst>
        </pc:picChg>
        <pc:picChg chg="mod ord">
          <ac:chgData name="Taishi Fukushima" userId="0760ddef824ae44c" providerId="LiveId" clId="{16C11474-64C2-4BDA-9CE0-16F24750807A}" dt="2025-01-12T04:07:18.803" v="98" actId="1076"/>
          <ac:picMkLst>
            <pc:docMk/>
            <pc:sldMk cId="2278013231" sldId="265"/>
            <ac:picMk id="34" creationId="{3B5FCC6B-51A2-F5B8-6B13-948722BC66DE}"/>
          </ac:picMkLst>
        </pc:picChg>
        <pc:picChg chg="add mod ord modCrop">
          <ac:chgData name="Taishi Fukushima" userId="0760ddef824ae44c" providerId="LiveId" clId="{16C11474-64C2-4BDA-9CE0-16F24750807A}" dt="2025-01-12T04:06:39.481" v="92" actId="1076"/>
          <ac:picMkLst>
            <pc:docMk/>
            <pc:sldMk cId="2278013231" sldId="265"/>
            <ac:picMk id="43" creationId="{8807E0D7-EA08-982C-1332-C1FDB2D348BF}"/>
          </ac:picMkLst>
        </pc:picChg>
        <pc:cxnChg chg="mod ord">
          <ac:chgData name="Taishi Fukushima" userId="0760ddef824ae44c" providerId="LiveId" clId="{16C11474-64C2-4BDA-9CE0-16F24750807A}" dt="2025-01-12T04:07:04.207" v="94" actId="1076"/>
          <ac:cxnSpMkLst>
            <pc:docMk/>
            <pc:sldMk cId="2278013231" sldId="265"/>
            <ac:cxnSpMk id="36" creationId="{C0F07241-9680-CAAF-A473-DD7753175C19}"/>
          </ac:cxnSpMkLst>
        </pc:cxnChg>
        <pc:cxnChg chg="mod ord">
          <ac:chgData name="Taishi Fukushima" userId="0760ddef824ae44c" providerId="LiveId" clId="{16C11474-64C2-4BDA-9CE0-16F24750807A}" dt="2025-01-12T04:07:12.294" v="96" actId="1076"/>
          <ac:cxnSpMkLst>
            <pc:docMk/>
            <pc:sldMk cId="2278013231" sldId="265"/>
            <ac:cxnSpMk id="50" creationId="{017127A7-0F74-4882-559B-43246BC0E3CC}"/>
          </ac:cxnSpMkLst>
        </pc:cxnChg>
        <pc:cxnChg chg="mod ord">
          <ac:chgData name="Taishi Fukushima" userId="0760ddef824ae44c" providerId="LiveId" clId="{16C11474-64C2-4BDA-9CE0-16F24750807A}" dt="2025-01-12T04:07:33.716" v="101" actId="14100"/>
          <ac:cxnSpMkLst>
            <pc:docMk/>
            <pc:sldMk cId="2278013231" sldId="265"/>
            <ac:cxnSpMk id="54" creationId="{C8D88BF9-4183-AE89-367A-0611573C5F1E}"/>
          </ac:cxnSpMkLst>
        </pc:cxnChg>
      </pc:sldChg>
    </pc:docChg>
  </pc:docChgLst>
  <pc:docChgLst>
    <pc:chgData name="Taishi Fukushima" userId="0760ddef824ae44c" providerId="LiveId" clId="{5C004DAF-F842-4711-9CB5-52BA40D86A9C}"/>
    <pc:docChg chg="undo redo custSel modSld sldOrd">
      <pc:chgData name="Taishi Fukushima" userId="0760ddef824ae44c" providerId="LiveId" clId="{5C004DAF-F842-4711-9CB5-52BA40D86A9C}" dt="2025-02-13T10:59:48.659" v="89" actId="1076"/>
      <pc:docMkLst>
        <pc:docMk/>
      </pc:docMkLst>
      <pc:sldChg chg="modSp mod">
        <pc:chgData name="Taishi Fukushima" userId="0760ddef824ae44c" providerId="LiveId" clId="{5C004DAF-F842-4711-9CB5-52BA40D86A9C}" dt="2025-02-13T10:59:41.234" v="88" actId="1076"/>
        <pc:sldMkLst>
          <pc:docMk/>
          <pc:sldMk cId="1181669990" sldId="263"/>
        </pc:sldMkLst>
        <pc:spChg chg="mod">
          <ac:chgData name="Taishi Fukushima" userId="0760ddef824ae44c" providerId="LiveId" clId="{5C004DAF-F842-4711-9CB5-52BA40D86A9C}" dt="2025-02-13T10:59:41.234" v="88" actId="1076"/>
          <ac:spMkLst>
            <pc:docMk/>
            <pc:sldMk cId="1181669990" sldId="263"/>
            <ac:spMk id="2" creationId="{7869663D-DEC6-FCE5-4B98-8345D65800D8}"/>
          </ac:spMkLst>
        </pc:spChg>
      </pc:sldChg>
      <pc:sldChg chg="modSp mod">
        <pc:chgData name="Taishi Fukushima" userId="0760ddef824ae44c" providerId="LiveId" clId="{5C004DAF-F842-4711-9CB5-52BA40D86A9C}" dt="2025-02-13T10:36:46.645" v="19" actId="14100"/>
        <pc:sldMkLst>
          <pc:docMk/>
          <pc:sldMk cId="1160549357" sldId="264"/>
        </pc:sldMkLst>
      </pc:sldChg>
      <pc:sldChg chg="modSp mod">
        <pc:chgData name="Taishi Fukushima" userId="0760ddef824ae44c" providerId="LiveId" clId="{5C004DAF-F842-4711-9CB5-52BA40D86A9C}" dt="2025-02-13T10:39:41.334" v="26" actId="20577"/>
        <pc:sldMkLst>
          <pc:docMk/>
          <pc:sldMk cId="2278013231" sldId="265"/>
        </pc:sldMkLst>
        <pc:spChg chg="mod">
          <ac:chgData name="Taishi Fukushima" userId="0760ddef824ae44c" providerId="LiveId" clId="{5C004DAF-F842-4711-9CB5-52BA40D86A9C}" dt="2025-02-13T10:39:41.334" v="26" actId="20577"/>
          <ac:spMkLst>
            <pc:docMk/>
            <pc:sldMk cId="2278013231" sldId="265"/>
            <ac:spMk id="2" creationId="{60EA70BC-4B21-6C72-DC59-A60EF6B60A57}"/>
          </ac:spMkLst>
        </pc:spChg>
      </pc:sldChg>
      <pc:sldChg chg="modSp mod ord">
        <pc:chgData name="Taishi Fukushima" userId="0760ddef824ae44c" providerId="LiveId" clId="{5C004DAF-F842-4711-9CB5-52BA40D86A9C}" dt="2025-02-13T10:59:48.659" v="89" actId="1076"/>
        <pc:sldMkLst>
          <pc:docMk/>
          <pc:sldMk cId="696647156" sldId="267"/>
        </pc:sldMkLst>
        <pc:spChg chg="mod">
          <ac:chgData name="Taishi Fukushima" userId="0760ddef824ae44c" providerId="LiveId" clId="{5C004DAF-F842-4711-9CB5-52BA40D86A9C}" dt="2025-02-13T10:59:48.659" v="89" actId="1076"/>
          <ac:spMkLst>
            <pc:docMk/>
            <pc:sldMk cId="696647156" sldId="267"/>
            <ac:spMk id="2" creationId="{13446B27-B96F-C0D4-9B6E-757C11FD9D72}"/>
          </ac:spMkLst>
        </pc:spChg>
      </pc:sldChg>
      <pc:sldChg chg="modSp mod ord">
        <pc:chgData name="Taishi Fukushima" userId="0760ddef824ae44c" providerId="LiveId" clId="{5C004DAF-F842-4711-9CB5-52BA40D86A9C}" dt="2025-02-13T10:39:14.769" v="22" actId="20577"/>
        <pc:sldMkLst>
          <pc:docMk/>
          <pc:sldMk cId="772001934" sldId="272"/>
        </pc:sldMkLst>
        <pc:spChg chg="mod">
          <ac:chgData name="Taishi Fukushima" userId="0760ddef824ae44c" providerId="LiveId" clId="{5C004DAF-F842-4711-9CB5-52BA40D86A9C}" dt="2025-02-13T10:39:14.769" v="22" actId="20577"/>
          <ac:spMkLst>
            <pc:docMk/>
            <pc:sldMk cId="772001934" sldId="272"/>
            <ac:spMk id="2" creationId="{86285499-68DD-16AA-3CBD-72AC8B36B01C}"/>
          </ac:spMkLst>
        </pc:spChg>
      </pc:sldChg>
      <pc:sldChg chg="delSp modSp mod ord">
        <pc:chgData name="Taishi Fukushima" userId="0760ddef824ae44c" providerId="LiveId" clId="{5C004DAF-F842-4711-9CB5-52BA40D86A9C}" dt="2025-02-13T10:56:59.562" v="86" actId="1076"/>
        <pc:sldMkLst>
          <pc:docMk/>
          <pc:sldMk cId="2584110875" sldId="278"/>
        </pc:sldMkLst>
      </pc:sldChg>
      <pc:sldChg chg="modSp mod ord">
        <pc:chgData name="Taishi Fukushima" userId="0760ddef824ae44c" providerId="LiveId" clId="{5C004DAF-F842-4711-9CB5-52BA40D86A9C}" dt="2025-02-13T10:59:34.979" v="87" actId="1076"/>
        <pc:sldMkLst>
          <pc:docMk/>
          <pc:sldMk cId="2618933052" sldId="279"/>
        </pc:sldMkLst>
        <pc:spChg chg="mod">
          <ac:chgData name="Taishi Fukushima" userId="0760ddef824ae44c" providerId="LiveId" clId="{5C004DAF-F842-4711-9CB5-52BA40D86A9C}" dt="2025-02-13T10:59:34.979" v="87" actId="1076"/>
          <ac:spMkLst>
            <pc:docMk/>
            <pc:sldMk cId="2618933052" sldId="279"/>
            <ac:spMk id="2" creationId="{1B9F17F2-465D-0BA9-97D7-FA345CB9A542}"/>
          </ac:spMkLst>
        </pc:spChg>
      </pc:sldChg>
    </pc:docChg>
  </pc:docChgLst>
  <pc:docChgLst>
    <pc:chgData name="Taishi Fukushima" userId="0760ddef824ae44c" providerId="LiveId" clId="{61B5A0C3-3077-41B6-94F8-BF400C31B804}"/>
    <pc:docChg chg="delSld">
      <pc:chgData name="Taishi Fukushima" userId="0760ddef824ae44c" providerId="LiveId" clId="{61B5A0C3-3077-41B6-94F8-BF400C31B804}" dt="2025-02-19T03:55:07.371" v="0" actId="47"/>
      <pc:docMkLst>
        <pc:docMk/>
      </pc:docMkLst>
      <pc:sldChg chg="del">
        <pc:chgData name="Taishi Fukushima" userId="0760ddef824ae44c" providerId="LiveId" clId="{61B5A0C3-3077-41B6-94F8-BF400C31B804}" dt="2025-02-19T03:55:07.371" v="0" actId="47"/>
        <pc:sldMkLst>
          <pc:docMk/>
          <pc:sldMk cId="596731952" sldId="261"/>
        </pc:sldMkLst>
      </pc:sldChg>
      <pc:sldChg chg="del">
        <pc:chgData name="Taishi Fukushima" userId="0760ddef824ae44c" providerId="LiveId" clId="{61B5A0C3-3077-41B6-94F8-BF400C31B804}" dt="2025-02-19T03:55:07.371" v="0" actId="47"/>
        <pc:sldMkLst>
          <pc:docMk/>
          <pc:sldMk cId="1160549357" sldId="264"/>
        </pc:sldMkLst>
      </pc:sldChg>
      <pc:sldChg chg="del">
        <pc:chgData name="Taishi Fukushima" userId="0760ddef824ae44c" providerId="LiveId" clId="{61B5A0C3-3077-41B6-94F8-BF400C31B804}" dt="2025-02-19T03:55:07.371" v="0" actId="47"/>
        <pc:sldMkLst>
          <pc:docMk/>
          <pc:sldMk cId="2584110875" sldId="278"/>
        </pc:sldMkLst>
      </pc:sldChg>
    </pc:docChg>
  </pc:docChgLst>
  <pc:docChgLst>
    <pc:chgData name="Taishi Fukushima" userId="0760ddef824ae44c" providerId="LiveId" clId="{963C62E9-2A46-4C7C-9F43-8EFECB290760}"/>
    <pc:docChg chg="modSld">
      <pc:chgData name="Taishi Fukushima" userId="0760ddef824ae44c" providerId="LiveId" clId="{963C62E9-2A46-4C7C-9F43-8EFECB290760}" dt="2025-03-25T04:11:19.208" v="6" actId="1076"/>
      <pc:docMkLst>
        <pc:docMk/>
      </pc:docMkLst>
      <pc:sldChg chg="modSp mod">
        <pc:chgData name="Taishi Fukushima" userId="0760ddef824ae44c" providerId="LiveId" clId="{963C62E9-2A46-4C7C-9F43-8EFECB290760}" dt="2025-03-25T04:11:19.208" v="6" actId="1076"/>
        <pc:sldMkLst>
          <pc:docMk/>
          <pc:sldMk cId="2278013231" sldId="265"/>
        </pc:sldMkLst>
        <pc:spChg chg="mod">
          <ac:chgData name="Taishi Fukushima" userId="0760ddef824ae44c" providerId="LiveId" clId="{963C62E9-2A46-4C7C-9F43-8EFECB290760}" dt="2025-03-25T04:11:19.208" v="6" actId="1076"/>
          <ac:spMkLst>
            <pc:docMk/>
            <pc:sldMk cId="2278013231" sldId="265"/>
            <ac:spMk id="6" creationId="{D829C505-36A7-B171-5BFE-DB149F470278}"/>
          </ac:spMkLst>
        </pc:spChg>
      </pc:sldChg>
    </pc:docChg>
  </pc:docChgLst>
  <pc:docChgLst>
    <pc:chgData name="Taishi Fukushima" userId="0760ddef824ae44c" providerId="LiveId" clId="{F23F31A8-162B-4ED3-AA11-15AEA58D8BDD}"/>
    <pc:docChg chg="undo custSel modSld">
      <pc:chgData name="Taishi Fukushima" userId="0760ddef824ae44c" providerId="LiveId" clId="{F23F31A8-162B-4ED3-AA11-15AEA58D8BDD}" dt="2025-01-10T13:33:26.095" v="67" actId="1076"/>
      <pc:docMkLst>
        <pc:docMk/>
      </pc:docMkLst>
      <pc:sldChg chg="addSp delSp modSp mod">
        <pc:chgData name="Taishi Fukushima" userId="0760ddef824ae44c" providerId="LiveId" clId="{F23F31A8-162B-4ED3-AA11-15AEA58D8BDD}" dt="2025-01-10T13:33:26.095" v="67" actId="1076"/>
        <pc:sldMkLst>
          <pc:docMk/>
          <pc:sldMk cId="2584110875" sldId="27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47675B-00E3-4A4B-B74D-3B8B216CA61C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AB3AB1-AC07-4266-9A8D-DCDA96AFEB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59718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AB3AB1-AC07-4266-9A8D-DCDA96AFEBC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50141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AB3AB1-AC07-4266-9A8D-DCDA96AFEBC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4961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AB3AB1-AC07-4266-9A8D-DCDA96AFEBC5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070653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9EB3B4F-1D4A-1465-4A47-257A654F07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2325B4F5-5708-436C-0C92-B4D6702A5C7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105AED34-8690-7284-FEE4-41B0C9BDCA5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1E71EED-1341-C43C-4F64-D345F71C180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AB3AB1-AC07-4266-9A8D-DCDA96AFEBC5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86091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B794E0-8819-D253-67B3-E599363B8E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885CB9D-65A8-657A-A40B-EC007256E2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64F832-8B05-D677-4FFA-36677C058A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B05D87-A2F0-A44D-23EB-0D738EB02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718E9F-C2AB-2437-C180-0D5FA11DA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365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44341E-37F2-EC66-CC83-959D3DA768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42FC34A-85B7-ECF4-6FE4-47FA073DC2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E32E9C-7601-5264-E840-0336B117F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6FDE76-86F1-15B6-D7A9-98D14661B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8AC284-37E4-DC20-D9BA-515D38A06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211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77982B2-0C44-93E7-755D-8A0C140E84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5D78915-6123-F12D-9167-213106457B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AE6AB4-03EA-8673-602D-04A8A51A3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644602-5225-DBD1-2B12-243640840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68CC6A-418E-99DA-8BF3-309E36061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168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7A456B-7020-4C48-5A53-F2B8916253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81107"/>
            <a:ext cx="10515600" cy="1325563"/>
          </a:xfrm>
        </p:spPr>
        <p:txBody>
          <a:bodyPr>
            <a:normAutofit/>
          </a:bodyPr>
          <a:lstStyle>
            <a:lvl1pPr>
              <a:defRPr sz="240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49EF03E-EF3E-0551-6426-D59F318177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34A7D4-E865-8590-D549-35C835A52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B584443-E893-7DCD-0A85-6143F697E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8F2213-03A7-BAA7-BFEB-8A3B4A36E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400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2F3870-6A74-4F3C-CC0E-AAA1776262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5BD107A-D13D-9EFB-5742-55D212F96C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43D32C7-0CED-09E0-C87F-58376BAC3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F43407-8603-BD3B-7ECA-F78D0FCB5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5E47A7-FD9D-8B0C-6DAA-93354C27D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78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AE6C89-4941-A8EC-4D43-9297B4CC3D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328DDA-630D-28D8-782B-A7C716F4BA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C0EBAB6-E0F1-5244-B7C4-C4DD824E97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E215BE2-6750-AAB0-EEA5-B2E9036BA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8887D0-ED1F-D53D-C04E-4885958E9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D9F5559-E568-73FE-C999-D12D1FCD0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846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7B053C-4196-0DC4-9A89-2C94584B0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C644507-B098-5FD0-3752-8C7E68D462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4EB165D-73C5-AE24-CAB2-A5140C3F00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A6CBCE0-3D0A-C3FB-4CA7-F6F910EAF2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46F9C80-948A-0F1E-5418-5271362335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C789426-7659-1FF5-4B56-193F10F53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90CE3BC-D2C2-55D5-CDF8-712923FCD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777E974-0C0C-7E67-AFE9-5F8AF2A70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882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319A82-C609-81B8-5B7E-4E0D6A80C8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9FD1178-35AB-F506-3C13-892E1A6F4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10B73B8-24EE-AE82-275B-E00461DBB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FC9852E-056A-6614-8D07-CE908D3E3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301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0A9B0EA-BE59-DA8E-4267-FD83A04EB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31EE8A0-1038-D2E9-C46F-1220943B44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4B088C4-9C35-9705-9495-F773B4E53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12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3FC350-CCA9-D94C-F706-7226DA4AD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3E86F5D-F6DB-47FE-EE2A-8BDC7D78D6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99AF938-7458-603A-95DD-04631F07E1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35D6CE2-C905-AFAC-0937-B45C74925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696402-8C0B-2C28-3A5B-DC835FB19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24046D-023C-5CF4-A579-1FC44256D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7684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3EB527-8832-BAF2-2170-81EE702748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00F7ACB-87E7-B08E-8BA4-8F8052765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FD78A4B-A214-6691-6835-B422E8F22E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91262A-D464-2790-8B83-AE9DE06C9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83B59F9-8397-6FC1-9E6E-346605DFD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A8D3E1C-488B-7186-B71C-F23DCDD5D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5489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A733BB5-3C42-B88E-CDA7-C92B648BF3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3894714-EEFF-2ADF-CD38-D419183B50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136664-010E-FCDE-A31F-B8CC7E5446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C6480-0CC8-4315-8742-EE19BBB47E88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A06618-0336-211B-7D72-00FBF9432D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AD4667-1EF6-EF96-EC36-13FCF41FF5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2A1B28-F3C7-4D6E-9DDD-A5B073A414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743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7A1BEA-9357-A56B-A4F7-DC60898AB4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9770"/>
            <a:ext cx="1797384" cy="368796"/>
          </a:xfrm>
        </p:spPr>
        <p:txBody>
          <a:bodyPr>
            <a:normAutofit/>
          </a:bodyPr>
          <a:lstStyle/>
          <a:p>
            <a:r>
              <a:rPr kumimoji="1" lang="en-US" altLang="ja-JP" sz="1600" b="1" dirty="0">
                <a:latin typeface="+mn-lt"/>
              </a:rPr>
              <a:t>Figure S1</a:t>
            </a:r>
            <a:endParaRPr kumimoji="1" lang="ja-JP" altLang="en-US" sz="1600" b="1" dirty="0">
              <a:latin typeface="+mn-lt"/>
            </a:endParaRPr>
          </a:p>
        </p:txBody>
      </p:sp>
      <p:pic>
        <p:nvPicPr>
          <p:cNvPr id="13" name="コンテンツ プレースホルダー 12">
            <a:extLst>
              <a:ext uri="{FF2B5EF4-FFF2-40B4-BE49-F238E27FC236}">
                <a16:creationId xmlns:a16="http://schemas.microsoft.com/office/drawing/2014/main" id="{F6C4290A-953A-6339-941B-83E5BC9C9C1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91855" y="781886"/>
            <a:ext cx="9266404" cy="5652164"/>
          </a:xfr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BAB89D7-D063-7E34-7400-5FCFE37B422C}"/>
              </a:ext>
            </a:extLst>
          </p:cNvPr>
          <p:cNvSpPr txBox="1"/>
          <p:nvPr/>
        </p:nvSpPr>
        <p:spPr>
          <a:xfrm>
            <a:off x="6516470" y="2457393"/>
            <a:ext cx="170451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t</a:t>
            </a:r>
            <a:r>
              <a:rPr kumimoji="1" lang="en-US" altLang="ja-JP" sz="1600" b="1" dirty="0"/>
              <a:t>ermination</a:t>
            </a:r>
            <a:endParaRPr kumimoji="1" lang="ja-JP" altLang="en-US" sz="1600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607BE32-41E0-E3E0-36A1-A03FBAE2C5CD}"/>
              </a:ext>
            </a:extLst>
          </p:cNvPr>
          <p:cNvSpPr txBox="1"/>
          <p:nvPr/>
        </p:nvSpPr>
        <p:spPr>
          <a:xfrm>
            <a:off x="1156645" y="1123586"/>
            <a:ext cx="4154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Ⅱ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176B362-EEB5-658A-E8B2-B0340CE6D6AF}"/>
              </a:ext>
            </a:extLst>
          </p:cNvPr>
          <p:cNvSpPr txBox="1"/>
          <p:nvPr/>
        </p:nvSpPr>
        <p:spPr>
          <a:xfrm>
            <a:off x="1156645" y="1430748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V1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7356315-BA83-A7C5-40A9-561AEE776A95}"/>
              </a:ext>
            </a:extLst>
          </p:cNvPr>
          <p:cNvSpPr txBox="1"/>
          <p:nvPr/>
        </p:nvSpPr>
        <p:spPr>
          <a:xfrm>
            <a:off x="1156645" y="1862336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V5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7EA7DA8-DF3B-A812-F712-59C35AE7C531}"/>
              </a:ext>
            </a:extLst>
          </p:cNvPr>
          <p:cNvSpPr txBox="1"/>
          <p:nvPr/>
        </p:nvSpPr>
        <p:spPr>
          <a:xfrm>
            <a:off x="603151" y="245739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SVC</a:t>
            </a:r>
          </a:p>
        </p:txBody>
      </p:sp>
      <p:sp>
        <p:nvSpPr>
          <p:cNvPr id="8" name="左中かっこ 7">
            <a:extLst>
              <a:ext uri="{FF2B5EF4-FFF2-40B4-BE49-F238E27FC236}">
                <a16:creationId xmlns:a16="http://schemas.microsoft.com/office/drawing/2014/main" id="{9E8BB272-3A0F-3AC7-1470-FF43D71AC2E2}"/>
              </a:ext>
            </a:extLst>
          </p:cNvPr>
          <p:cNvSpPr/>
          <p:nvPr/>
        </p:nvSpPr>
        <p:spPr>
          <a:xfrm>
            <a:off x="1180800" y="2437852"/>
            <a:ext cx="158400" cy="401851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C0F0894-2622-510C-146C-AA30D99689F6}"/>
              </a:ext>
            </a:extLst>
          </p:cNvPr>
          <p:cNvSpPr txBox="1"/>
          <p:nvPr/>
        </p:nvSpPr>
        <p:spPr>
          <a:xfrm>
            <a:off x="1261541" y="223171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d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4280B48-371A-AEDD-B459-5769C95CB423}"/>
              </a:ext>
            </a:extLst>
          </p:cNvPr>
          <p:cNvSpPr txBox="1"/>
          <p:nvPr/>
        </p:nvSpPr>
        <p:spPr>
          <a:xfrm>
            <a:off x="1261541" y="262294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p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3F62A93-EAA5-28B2-9ADF-26F34B689916}"/>
              </a:ext>
            </a:extLst>
          </p:cNvPr>
          <p:cNvSpPr txBox="1"/>
          <p:nvPr/>
        </p:nvSpPr>
        <p:spPr>
          <a:xfrm>
            <a:off x="730702" y="3604166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RA</a:t>
            </a:r>
          </a:p>
        </p:txBody>
      </p:sp>
      <p:sp>
        <p:nvSpPr>
          <p:cNvPr id="12" name="左中かっこ 11">
            <a:extLst>
              <a:ext uri="{FF2B5EF4-FFF2-40B4-BE49-F238E27FC236}">
                <a16:creationId xmlns:a16="http://schemas.microsoft.com/office/drawing/2014/main" id="{2AB4DB9B-D275-04FF-5A55-197FF0767AF7}"/>
              </a:ext>
            </a:extLst>
          </p:cNvPr>
          <p:cNvSpPr/>
          <p:nvPr/>
        </p:nvSpPr>
        <p:spPr>
          <a:xfrm>
            <a:off x="1180800" y="3181537"/>
            <a:ext cx="158400" cy="1209220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>
              <a:latin typeface="+mj-ea"/>
              <a:ea typeface="+mj-e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8834263-D0C6-E9B4-E1C8-C8505A08411C}"/>
              </a:ext>
            </a:extLst>
          </p:cNvPr>
          <p:cNvSpPr txBox="1"/>
          <p:nvPr/>
        </p:nvSpPr>
        <p:spPr>
          <a:xfrm>
            <a:off x="1261541" y="298878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d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9CAEC70-C02F-991F-7C04-956C0CB95669}"/>
              </a:ext>
            </a:extLst>
          </p:cNvPr>
          <p:cNvSpPr txBox="1"/>
          <p:nvPr/>
        </p:nvSpPr>
        <p:spPr>
          <a:xfrm>
            <a:off x="1261541" y="414977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p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7" name="左中かっこ 16">
            <a:extLst>
              <a:ext uri="{FF2B5EF4-FFF2-40B4-BE49-F238E27FC236}">
                <a16:creationId xmlns:a16="http://schemas.microsoft.com/office/drawing/2014/main" id="{CA1D5039-4892-0C00-5398-83DD0D01B48A}"/>
              </a:ext>
            </a:extLst>
          </p:cNvPr>
          <p:cNvSpPr/>
          <p:nvPr/>
        </p:nvSpPr>
        <p:spPr>
          <a:xfrm>
            <a:off x="1180800" y="4718549"/>
            <a:ext cx="158400" cy="1209221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>
              <a:latin typeface="+mj-ea"/>
              <a:ea typeface="+mj-ea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DC38824-7EF2-9D7E-7E79-99E9774E3CCB}"/>
              </a:ext>
            </a:extLst>
          </p:cNvPr>
          <p:cNvSpPr txBox="1"/>
          <p:nvPr/>
        </p:nvSpPr>
        <p:spPr>
          <a:xfrm>
            <a:off x="1261541" y="454782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d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ECA1EA2-93D5-00F8-1D02-EDE20AADD750}"/>
              </a:ext>
            </a:extLst>
          </p:cNvPr>
          <p:cNvSpPr txBox="1"/>
          <p:nvPr/>
        </p:nvSpPr>
        <p:spPr>
          <a:xfrm>
            <a:off x="1261541" y="570881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p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89CDE8E-DFE0-54E9-585D-7448BE2800FF}"/>
              </a:ext>
            </a:extLst>
          </p:cNvPr>
          <p:cNvSpPr txBox="1"/>
          <p:nvPr/>
        </p:nvSpPr>
        <p:spPr>
          <a:xfrm>
            <a:off x="743526" y="514551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CS</a:t>
            </a:r>
          </a:p>
        </p:txBody>
      </p:sp>
    </p:spTree>
    <p:extLst>
      <p:ext uri="{BB962C8B-B14F-4D97-AF65-F5344CB8AC3E}">
        <p14:creationId xmlns:p14="http://schemas.microsoft.com/office/powerpoint/2010/main" val="3946388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1DE27B-4629-B458-E338-FEFC384C33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712"/>
            <a:ext cx="1773455" cy="369332"/>
          </a:xfrm>
        </p:spPr>
        <p:txBody>
          <a:bodyPr>
            <a:normAutofit/>
          </a:bodyPr>
          <a:lstStyle/>
          <a:p>
            <a:r>
              <a:rPr kumimoji="1" lang="en-US" altLang="ja-JP" sz="1600" b="1" dirty="0">
                <a:latin typeface="+mn-lt"/>
              </a:rPr>
              <a:t>Figure S2</a:t>
            </a:r>
            <a:endParaRPr kumimoji="1" lang="ja-JP" altLang="en-US" sz="1600" b="1" dirty="0">
              <a:latin typeface="+mn-lt"/>
            </a:endParaRPr>
          </a:p>
        </p:txBody>
      </p:sp>
      <p:pic>
        <p:nvPicPr>
          <p:cNvPr id="13" name="コンテンツ プレースホルダー 12">
            <a:extLst>
              <a:ext uri="{FF2B5EF4-FFF2-40B4-BE49-F238E27FC236}">
                <a16:creationId xmlns:a16="http://schemas.microsoft.com/office/drawing/2014/main" id="{BE9C92FF-5A62-802B-1A99-3CB5BD2E44E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369" r="666"/>
          <a:stretch/>
        </p:blipFill>
        <p:spPr>
          <a:xfrm>
            <a:off x="1730847" y="639910"/>
            <a:ext cx="9380632" cy="5652000"/>
          </a:xfr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378F459-1D36-3080-A1E6-3B09BA42F67E}"/>
              </a:ext>
            </a:extLst>
          </p:cNvPr>
          <p:cNvSpPr txBox="1"/>
          <p:nvPr/>
        </p:nvSpPr>
        <p:spPr>
          <a:xfrm>
            <a:off x="1238632" y="924802"/>
            <a:ext cx="4154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Ⅱ</a:t>
            </a:r>
            <a:endParaRPr kumimoji="1" lang="ja-JP" altLang="en-US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8936931-C378-BDBA-EC37-1F3843270027}"/>
              </a:ext>
            </a:extLst>
          </p:cNvPr>
          <p:cNvSpPr txBox="1"/>
          <p:nvPr/>
        </p:nvSpPr>
        <p:spPr>
          <a:xfrm>
            <a:off x="1212984" y="1340073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V1</a:t>
            </a:r>
            <a:endParaRPr kumimoji="1" lang="ja-JP" altLang="en-US" b="1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20726E1-0E7F-BED3-68A1-5188B05EA2CA}"/>
              </a:ext>
            </a:extLst>
          </p:cNvPr>
          <p:cNvSpPr txBox="1"/>
          <p:nvPr/>
        </p:nvSpPr>
        <p:spPr>
          <a:xfrm>
            <a:off x="1212984" y="1726463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V5</a:t>
            </a:r>
            <a:endParaRPr kumimoji="1" lang="ja-JP" altLang="en-US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AA1616F-AAA6-1C4C-CC8A-93A2CBF1AD1C}"/>
              </a:ext>
            </a:extLst>
          </p:cNvPr>
          <p:cNvSpPr txBox="1"/>
          <p:nvPr/>
        </p:nvSpPr>
        <p:spPr>
          <a:xfrm>
            <a:off x="651190" y="232010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VC</a:t>
            </a:r>
          </a:p>
        </p:txBody>
      </p:sp>
      <p:sp>
        <p:nvSpPr>
          <p:cNvPr id="7" name="左中かっこ 6">
            <a:extLst>
              <a:ext uri="{FF2B5EF4-FFF2-40B4-BE49-F238E27FC236}">
                <a16:creationId xmlns:a16="http://schemas.microsoft.com/office/drawing/2014/main" id="{2AA4D7B1-31E7-D236-F85D-D9140B0FEA09}"/>
              </a:ext>
            </a:extLst>
          </p:cNvPr>
          <p:cNvSpPr/>
          <p:nvPr/>
        </p:nvSpPr>
        <p:spPr>
          <a:xfrm>
            <a:off x="1249200" y="2303844"/>
            <a:ext cx="158400" cy="401851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3E815D3-A8B1-B363-3550-A6DE64BCB912}"/>
              </a:ext>
            </a:extLst>
          </p:cNvPr>
          <p:cNvSpPr txBox="1"/>
          <p:nvPr/>
        </p:nvSpPr>
        <p:spPr>
          <a:xfrm>
            <a:off x="1328400" y="209770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d</a:t>
            </a:r>
            <a:endParaRPr kumimoji="1" lang="ja-JP" altLang="en-US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3012F1D-5068-47D6-A0EA-91115F47DCE2}"/>
              </a:ext>
            </a:extLst>
          </p:cNvPr>
          <p:cNvSpPr txBox="1"/>
          <p:nvPr/>
        </p:nvSpPr>
        <p:spPr>
          <a:xfrm>
            <a:off x="1328400" y="248894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p</a:t>
            </a:r>
            <a:endParaRPr kumimoji="1" lang="ja-JP" altLang="en-US" b="1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0C000EC-611A-B709-5EF4-0C721490BC6D}"/>
              </a:ext>
            </a:extLst>
          </p:cNvPr>
          <p:cNvSpPr txBox="1"/>
          <p:nvPr/>
        </p:nvSpPr>
        <p:spPr>
          <a:xfrm>
            <a:off x="779454" y="3454400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RA</a:t>
            </a:r>
          </a:p>
        </p:txBody>
      </p:sp>
      <p:sp>
        <p:nvSpPr>
          <p:cNvPr id="11" name="左中かっこ 10">
            <a:extLst>
              <a:ext uri="{FF2B5EF4-FFF2-40B4-BE49-F238E27FC236}">
                <a16:creationId xmlns:a16="http://schemas.microsoft.com/office/drawing/2014/main" id="{70C9560E-03DD-7214-4C2B-EE8E07EB49A2}"/>
              </a:ext>
            </a:extLst>
          </p:cNvPr>
          <p:cNvSpPr/>
          <p:nvPr/>
        </p:nvSpPr>
        <p:spPr>
          <a:xfrm>
            <a:off x="1249200" y="3073400"/>
            <a:ext cx="158400" cy="1151894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809D100-4F66-FF01-6535-762FA786CFC6}"/>
              </a:ext>
            </a:extLst>
          </p:cNvPr>
          <p:cNvSpPr txBox="1"/>
          <p:nvPr/>
        </p:nvSpPr>
        <p:spPr>
          <a:xfrm>
            <a:off x="1328400" y="287381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d</a:t>
            </a:r>
            <a:endParaRPr kumimoji="1" lang="ja-JP" altLang="en-US" b="1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09929F5-B381-71F4-0F6D-381727296E25}"/>
              </a:ext>
            </a:extLst>
          </p:cNvPr>
          <p:cNvSpPr txBox="1"/>
          <p:nvPr/>
        </p:nvSpPr>
        <p:spPr>
          <a:xfrm>
            <a:off x="1328400" y="402824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p</a:t>
            </a:r>
            <a:endParaRPr kumimoji="1" lang="ja-JP" altLang="en-US" b="1" dirty="0"/>
          </a:p>
        </p:txBody>
      </p:sp>
      <p:sp>
        <p:nvSpPr>
          <p:cNvPr id="15" name="左中かっこ 14">
            <a:extLst>
              <a:ext uri="{FF2B5EF4-FFF2-40B4-BE49-F238E27FC236}">
                <a16:creationId xmlns:a16="http://schemas.microsoft.com/office/drawing/2014/main" id="{79C4299C-E604-4889-7942-E92606B231CA}"/>
              </a:ext>
            </a:extLst>
          </p:cNvPr>
          <p:cNvSpPr/>
          <p:nvPr/>
        </p:nvSpPr>
        <p:spPr>
          <a:xfrm>
            <a:off x="1249200" y="4624637"/>
            <a:ext cx="158400" cy="1181600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DD08380-8BB7-33D9-F264-DD1C7BE2B19D}"/>
              </a:ext>
            </a:extLst>
          </p:cNvPr>
          <p:cNvSpPr txBox="1"/>
          <p:nvPr/>
        </p:nvSpPr>
        <p:spPr>
          <a:xfrm>
            <a:off x="1328400" y="442629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d</a:t>
            </a:r>
            <a:endParaRPr kumimoji="1" lang="ja-JP" altLang="en-US" b="1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E45E34C-5F10-6AF9-929D-8D2182FAE653}"/>
              </a:ext>
            </a:extLst>
          </p:cNvPr>
          <p:cNvSpPr txBox="1"/>
          <p:nvPr/>
        </p:nvSpPr>
        <p:spPr>
          <a:xfrm>
            <a:off x="1328400" y="558727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p</a:t>
            </a:r>
            <a:endParaRPr kumimoji="1" lang="ja-JP" altLang="en-US" b="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45CC445-127A-4213-8AED-D8045FB0D128}"/>
              </a:ext>
            </a:extLst>
          </p:cNvPr>
          <p:cNvSpPr txBox="1"/>
          <p:nvPr/>
        </p:nvSpPr>
        <p:spPr>
          <a:xfrm>
            <a:off x="780033" y="5030771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CS</a:t>
            </a: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FAFE0D83-D744-17C7-73F5-16878966EB0E}"/>
              </a:ext>
            </a:extLst>
          </p:cNvPr>
          <p:cNvCxnSpPr/>
          <p:nvPr/>
        </p:nvCxnSpPr>
        <p:spPr>
          <a:xfrm flipV="1">
            <a:off x="2108200" y="5207000"/>
            <a:ext cx="169333" cy="749611"/>
          </a:xfrm>
          <a:prstGeom prst="straightConnector1">
            <a:avLst/>
          </a:prstGeom>
          <a:ln w="22225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9E86357C-C32E-A3E2-EBB5-33CC7DB8AD24}"/>
              </a:ext>
            </a:extLst>
          </p:cNvPr>
          <p:cNvCxnSpPr/>
          <p:nvPr/>
        </p:nvCxnSpPr>
        <p:spPr>
          <a:xfrm flipV="1">
            <a:off x="3894666" y="5215437"/>
            <a:ext cx="169333" cy="749611"/>
          </a:xfrm>
          <a:prstGeom prst="straightConnector1">
            <a:avLst/>
          </a:prstGeom>
          <a:ln w="22225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4E48F0C8-2381-7691-C81E-17D80A004569}"/>
              </a:ext>
            </a:extLst>
          </p:cNvPr>
          <p:cNvCxnSpPr/>
          <p:nvPr/>
        </p:nvCxnSpPr>
        <p:spPr>
          <a:xfrm flipV="1">
            <a:off x="5643548" y="5206999"/>
            <a:ext cx="169333" cy="749611"/>
          </a:xfrm>
          <a:prstGeom prst="straightConnector1">
            <a:avLst/>
          </a:prstGeom>
          <a:ln w="22225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012286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285499-68DD-16AA-3CBD-72AC8B36B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140" y="11755"/>
            <a:ext cx="1774371" cy="309087"/>
          </a:xfrm>
        </p:spPr>
        <p:txBody>
          <a:bodyPr>
            <a:noAutofit/>
          </a:bodyPr>
          <a:lstStyle/>
          <a:p>
            <a:r>
              <a:rPr kumimoji="1" lang="en-US" altLang="ja-JP" sz="1600" b="1" dirty="0">
                <a:latin typeface="+mn-lt"/>
              </a:rPr>
              <a:t>Figure S3</a:t>
            </a:r>
            <a:endParaRPr kumimoji="1" lang="ja-JP" altLang="en-US" sz="1600" b="1" dirty="0">
              <a:latin typeface="+mn-lt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EDBA133-7D95-48C8-C700-A166D5E39061}"/>
              </a:ext>
            </a:extLst>
          </p:cNvPr>
          <p:cNvSpPr txBox="1"/>
          <p:nvPr/>
        </p:nvSpPr>
        <p:spPr>
          <a:xfrm>
            <a:off x="3508478" y="569940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A</a:t>
            </a:r>
            <a:endParaRPr kumimoji="1" lang="ja-JP" altLang="en-US" sz="2000" b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94266C0-B205-1DDC-E290-3E55A2B7918E}"/>
              </a:ext>
            </a:extLst>
          </p:cNvPr>
          <p:cNvSpPr txBox="1"/>
          <p:nvPr/>
        </p:nvSpPr>
        <p:spPr>
          <a:xfrm>
            <a:off x="8399996" y="5699402"/>
            <a:ext cx="3706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/>
              <a:t>B</a:t>
            </a:r>
            <a:endParaRPr kumimoji="1" lang="ja-JP" altLang="en-US" sz="2000" b="1" dirty="0"/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85665C4D-1194-92C1-D5A0-3CDA4E2A4E1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96039" y="1128096"/>
            <a:ext cx="9561597" cy="4601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20019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図 42">
            <a:extLst>
              <a:ext uri="{FF2B5EF4-FFF2-40B4-BE49-F238E27FC236}">
                <a16:creationId xmlns:a16="http://schemas.microsoft.com/office/drawing/2014/main" id="{8807E0D7-EA08-982C-1332-C1FDB2D348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21"/>
          <a:stretch/>
        </p:blipFill>
        <p:spPr>
          <a:xfrm>
            <a:off x="1696352" y="742672"/>
            <a:ext cx="9396043" cy="5786134"/>
          </a:xfrm>
          <a:prstGeom prst="rect">
            <a:avLst/>
          </a:prstGeom>
        </p:spPr>
      </p:pic>
      <p:sp>
        <p:nvSpPr>
          <p:cNvPr id="2" name="タイトル 1">
            <a:extLst>
              <a:ext uri="{FF2B5EF4-FFF2-40B4-BE49-F238E27FC236}">
                <a16:creationId xmlns:a16="http://schemas.microsoft.com/office/drawing/2014/main" id="{60EA70BC-4B21-6C72-DC59-A60EF6B60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5990"/>
            <a:ext cx="1937084" cy="369332"/>
          </a:xfrm>
        </p:spPr>
        <p:txBody>
          <a:bodyPr>
            <a:normAutofit/>
          </a:bodyPr>
          <a:lstStyle/>
          <a:p>
            <a:r>
              <a:rPr kumimoji="1" lang="en-US" altLang="ja-JP" sz="1600" b="1" dirty="0"/>
              <a:t>Figure </a:t>
            </a:r>
            <a:r>
              <a:rPr lang="en-US" altLang="ja-JP" sz="1600" b="1" dirty="0"/>
              <a:t>S4</a:t>
            </a:r>
            <a:endParaRPr kumimoji="1" lang="ja-JP" altLang="en-US" sz="1600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B3F88F9-48A7-9616-9CCD-6FA513B1EE10}"/>
              </a:ext>
            </a:extLst>
          </p:cNvPr>
          <p:cNvSpPr txBox="1"/>
          <p:nvPr/>
        </p:nvSpPr>
        <p:spPr>
          <a:xfrm>
            <a:off x="1301343" y="1073047"/>
            <a:ext cx="4154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Ⅱ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7142F6-A355-5B8F-90C2-098A7392B01C}"/>
              </a:ext>
            </a:extLst>
          </p:cNvPr>
          <p:cNvSpPr txBox="1"/>
          <p:nvPr/>
        </p:nvSpPr>
        <p:spPr>
          <a:xfrm>
            <a:off x="1301343" y="1470987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V1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7C566FF-485C-C0C5-2FA3-84DB6D33D135}"/>
              </a:ext>
            </a:extLst>
          </p:cNvPr>
          <p:cNvSpPr txBox="1"/>
          <p:nvPr/>
        </p:nvSpPr>
        <p:spPr>
          <a:xfrm>
            <a:off x="1301343" y="1888014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V5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829C505-36A7-B171-5BFE-DB149F470278}"/>
              </a:ext>
            </a:extLst>
          </p:cNvPr>
          <p:cNvSpPr txBox="1"/>
          <p:nvPr/>
        </p:nvSpPr>
        <p:spPr>
          <a:xfrm>
            <a:off x="692237" y="4144908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VOM</a:t>
            </a:r>
          </a:p>
        </p:txBody>
      </p:sp>
      <p:sp>
        <p:nvSpPr>
          <p:cNvPr id="7" name="左中かっこ 6">
            <a:extLst>
              <a:ext uri="{FF2B5EF4-FFF2-40B4-BE49-F238E27FC236}">
                <a16:creationId xmlns:a16="http://schemas.microsoft.com/office/drawing/2014/main" id="{544BDFF9-39F4-E078-3DFD-7D4D089D3C41}"/>
              </a:ext>
            </a:extLst>
          </p:cNvPr>
          <p:cNvSpPr/>
          <p:nvPr/>
        </p:nvSpPr>
        <p:spPr>
          <a:xfrm>
            <a:off x="1327289" y="4031307"/>
            <a:ext cx="158400" cy="593462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8936894-FCF1-666A-3F48-B3D89AC1EA7D}"/>
              </a:ext>
            </a:extLst>
          </p:cNvPr>
          <p:cNvSpPr txBox="1"/>
          <p:nvPr/>
        </p:nvSpPr>
        <p:spPr>
          <a:xfrm>
            <a:off x="1413689" y="382516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d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6F211A9-5522-22B2-4F80-A49FEE241761}"/>
              </a:ext>
            </a:extLst>
          </p:cNvPr>
          <p:cNvSpPr txBox="1"/>
          <p:nvPr/>
        </p:nvSpPr>
        <p:spPr>
          <a:xfrm>
            <a:off x="1413689" y="440063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p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B7BE666-A5E6-3121-8977-79FD3AD7E3F4}"/>
              </a:ext>
            </a:extLst>
          </p:cNvPr>
          <p:cNvSpPr txBox="1"/>
          <p:nvPr/>
        </p:nvSpPr>
        <p:spPr>
          <a:xfrm>
            <a:off x="884597" y="2891171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RA</a:t>
            </a:r>
          </a:p>
        </p:txBody>
      </p:sp>
      <p:sp>
        <p:nvSpPr>
          <p:cNvPr id="12" name="左中かっこ 11">
            <a:extLst>
              <a:ext uri="{FF2B5EF4-FFF2-40B4-BE49-F238E27FC236}">
                <a16:creationId xmlns:a16="http://schemas.microsoft.com/office/drawing/2014/main" id="{6275FC12-9187-9B1C-3AA4-42709E9E1A8A}"/>
              </a:ext>
            </a:extLst>
          </p:cNvPr>
          <p:cNvSpPr/>
          <p:nvPr/>
        </p:nvSpPr>
        <p:spPr>
          <a:xfrm>
            <a:off x="1327289" y="2474144"/>
            <a:ext cx="158400" cy="1209220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>
              <a:latin typeface="+mj-ea"/>
              <a:ea typeface="+mj-ea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DF9DB3B-70CA-D1F2-3939-50D73918404A}"/>
              </a:ext>
            </a:extLst>
          </p:cNvPr>
          <p:cNvSpPr txBox="1"/>
          <p:nvPr/>
        </p:nvSpPr>
        <p:spPr>
          <a:xfrm>
            <a:off x="1413689" y="227690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d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B68D9A5-6C8D-56B2-A945-4FFCE64FECBD}"/>
              </a:ext>
            </a:extLst>
          </p:cNvPr>
          <p:cNvSpPr txBox="1"/>
          <p:nvPr/>
        </p:nvSpPr>
        <p:spPr>
          <a:xfrm>
            <a:off x="1413689" y="344238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p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5" name="左中かっこ 14">
            <a:extLst>
              <a:ext uri="{FF2B5EF4-FFF2-40B4-BE49-F238E27FC236}">
                <a16:creationId xmlns:a16="http://schemas.microsoft.com/office/drawing/2014/main" id="{2E1DDA89-4736-C1F0-7021-9F3B7FBBF7A4}"/>
              </a:ext>
            </a:extLst>
          </p:cNvPr>
          <p:cNvSpPr/>
          <p:nvPr/>
        </p:nvSpPr>
        <p:spPr>
          <a:xfrm>
            <a:off x="1327289" y="5086313"/>
            <a:ext cx="158400" cy="1197075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>
              <a:latin typeface="+mj-ea"/>
              <a:ea typeface="+mj-ea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9D286C7-D61D-0579-7751-7B95E9402E55}"/>
              </a:ext>
            </a:extLst>
          </p:cNvPr>
          <p:cNvSpPr txBox="1"/>
          <p:nvPr/>
        </p:nvSpPr>
        <p:spPr>
          <a:xfrm>
            <a:off x="1413689" y="491558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d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A589911-DA33-8DB2-DC53-B1F4DF7688B5}"/>
              </a:ext>
            </a:extLst>
          </p:cNvPr>
          <p:cNvSpPr txBox="1"/>
          <p:nvPr/>
        </p:nvSpPr>
        <p:spPr>
          <a:xfrm>
            <a:off x="1413689" y="604077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p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69CB371-BCA6-E837-DF55-BDB35A558180}"/>
              </a:ext>
            </a:extLst>
          </p:cNvPr>
          <p:cNvSpPr txBox="1"/>
          <p:nvPr/>
        </p:nvSpPr>
        <p:spPr>
          <a:xfrm>
            <a:off x="897421" y="550018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CS</a:t>
            </a: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32AA9C9A-BF0F-6FF5-A12E-05F9E758BC5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0369" y="3599629"/>
            <a:ext cx="611888" cy="308589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809920B7-CF6C-1185-30B2-F06039B5714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2419" y="3599629"/>
            <a:ext cx="619842" cy="309921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3B5FCC6B-51A2-F5B8-6B13-948722BC66D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2428" y="3599629"/>
            <a:ext cx="619842" cy="309921"/>
          </a:xfrm>
          <a:prstGeom prst="rect">
            <a:avLst/>
          </a:prstGeom>
        </p:spPr>
      </p:pic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C0F07241-9680-CAAF-A473-DD7753175C19}"/>
              </a:ext>
            </a:extLst>
          </p:cNvPr>
          <p:cNvCxnSpPr>
            <a:cxnSpLocks/>
          </p:cNvCxnSpPr>
          <p:nvPr/>
        </p:nvCxnSpPr>
        <p:spPr>
          <a:xfrm>
            <a:off x="3882575" y="3887453"/>
            <a:ext cx="544549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id="{017127A7-0F74-4882-559B-43246BC0E3CC}"/>
              </a:ext>
            </a:extLst>
          </p:cNvPr>
          <p:cNvCxnSpPr>
            <a:cxnSpLocks/>
          </p:cNvCxnSpPr>
          <p:nvPr/>
        </p:nvCxnSpPr>
        <p:spPr>
          <a:xfrm>
            <a:off x="4972402" y="3879181"/>
            <a:ext cx="652784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C8D88BF9-4183-AE89-367A-0611573C5F1E}"/>
              </a:ext>
            </a:extLst>
          </p:cNvPr>
          <p:cNvCxnSpPr>
            <a:cxnSpLocks/>
          </p:cNvCxnSpPr>
          <p:nvPr/>
        </p:nvCxnSpPr>
        <p:spPr>
          <a:xfrm>
            <a:off x="6203378" y="3879181"/>
            <a:ext cx="595091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780132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233CE4-89CF-9979-4AFA-76AB416E30C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9F17F2-465D-0BA9-97D7-FA345CB9A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52300"/>
            <a:ext cx="2356396" cy="495953"/>
          </a:xfrm>
        </p:spPr>
        <p:txBody>
          <a:bodyPr>
            <a:normAutofit/>
          </a:bodyPr>
          <a:lstStyle/>
          <a:p>
            <a:r>
              <a:rPr kumimoji="1" lang="en-US" altLang="ja-JP" sz="1600" b="1" dirty="0">
                <a:latin typeface="+mn-lt"/>
              </a:rPr>
              <a:t>Figure S5</a:t>
            </a:r>
            <a:endParaRPr kumimoji="1" lang="ja-JP" altLang="en-US" sz="1600" b="1" dirty="0">
              <a:latin typeface="+mn-lt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E9F01867-BBE5-76FE-4DDE-3A3ACE71839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71" b="1"/>
          <a:stretch/>
        </p:blipFill>
        <p:spPr>
          <a:xfrm>
            <a:off x="207166" y="1805619"/>
            <a:ext cx="3497957" cy="3521243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30EB9B1-DFD5-BA4C-EDD1-FD08B5F1BC95}"/>
              </a:ext>
            </a:extLst>
          </p:cNvPr>
          <p:cNvSpPr txBox="1"/>
          <p:nvPr/>
        </p:nvSpPr>
        <p:spPr>
          <a:xfrm>
            <a:off x="1985782" y="133785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A</a:t>
            </a:r>
            <a:endParaRPr kumimoji="1" lang="ja-JP" altLang="en-US" sz="2000" b="1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4B9AFD9-3E53-28B6-5285-8651168E3BBE}"/>
              </a:ext>
            </a:extLst>
          </p:cNvPr>
          <p:cNvSpPr txBox="1"/>
          <p:nvPr/>
        </p:nvSpPr>
        <p:spPr>
          <a:xfrm>
            <a:off x="4591692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B</a:t>
            </a:r>
            <a:endParaRPr kumimoji="1" lang="ja-JP" altLang="en-US" sz="2000" b="1" dirty="0"/>
          </a:p>
        </p:txBody>
      </p:sp>
      <p:pic>
        <p:nvPicPr>
          <p:cNvPr id="38" name="図 37">
            <a:extLst>
              <a:ext uri="{FF2B5EF4-FFF2-40B4-BE49-F238E27FC236}">
                <a16:creationId xmlns:a16="http://schemas.microsoft.com/office/drawing/2014/main" id="{A088B291-861A-181A-9B49-F377B6F67BD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0699" y="78938"/>
            <a:ext cx="7924877" cy="67001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89330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69663D-DEC6-FCE5-4B98-8345D65800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54391"/>
            <a:ext cx="1829373" cy="324296"/>
          </a:xfrm>
        </p:spPr>
        <p:txBody>
          <a:bodyPr>
            <a:normAutofit/>
          </a:bodyPr>
          <a:lstStyle/>
          <a:p>
            <a:r>
              <a:rPr kumimoji="1" lang="en-US" altLang="ja-JP" sz="1600" b="1" dirty="0">
                <a:latin typeface="+mn-lt"/>
              </a:rPr>
              <a:t>Figure </a:t>
            </a:r>
            <a:r>
              <a:rPr lang="en-US" altLang="ja-JP" sz="1600" b="1" dirty="0">
                <a:latin typeface="+mn-lt"/>
              </a:rPr>
              <a:t>S6</a:t>
            </a:r>
            <a:endParaRPr kumimoji="1" lang="ja-JP" altLang="en-US" sz="1600" b="1" dirty="0">
              <a:latin typeface="+mn-lt"/>
            </a:endParaRPr>
          </a:p>
        </p:txBody>
      </p:sp>
      <p:pic>
        <p:nvPicPr>
          <p:cNvPr id="9" name="コンテンツ プレースホルダー 8">
            <a:extLst>
              <a:ext uri="{FF2B5EF4-FFF2-40B4-BE49-F238E27FC236}">
                <a16:creationId xmlns:a16="http://schemas.microsoft.com/office/drawing/2014/main" id="{33609753-153E-787C-2335-671D33DD8A9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17801" y="827313"/>
            <a:ext cx="9279856" cy="5652000"/>
          </a:xfr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31B92B1-FCBD-9742-99BD-B05A08594C4C}"/>
              </a:ext>
            </a:extLst>
          </p:cNvPr>
          <p:cNvSpPr txBox="1"/>
          <p:nvPr/>
        </p:nvSpPr>
        <p:spPr>
          <a:xfrm>
            <a:off x="4955371" y="2391581"/>
            <a:ext cx="159274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t</a:t>
            </a:r>
            <a:r>
              <a:rPr kumimoji="1" lang="en-US" altLang="ja-JP" sz="1600" b="1" dirty="0"/>
              <a:t>ermination</a:t>
            </a:r>
            <a:endParaRPr kumimoji="1" lang="ja-JP" altLang="en-US" sz="1600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872E2E7-8991-5156-95D6-D8FFB7644E4C}"/>
              </a:ext>
            </a:extLst>
          </p:cNvPr>
          <p:cNvSpPr txBox="1"/>
          <p:nvPr/>
        </p:nvSpPr>
        <p:spPr>
          <a:xfrm>
            <a:off x="1238059" y="1071926"/>
            <a:ext cx="4154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Ⅱ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7F86579-6905-D777-CC02-6D6FBAA78323}"/>
              </a:ext>
            </a:extLst>
          </p:cNvPr>
          <p:cNvSpPr txBox="1"/>
          <p:nvPr/>
        </p:nvSpPr>
        <p:spPr>
          <a:xfrm>
            <a:off x="1238059" y="1469866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V1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AB9B692-959F-CB43-C5A9-E0E8643C0CD8}"/>
              </a:ext>
            </a:extLst>
          </p:cNvPr>
          <p:cNvSpPr txBox="1"/>
          <p:nvPr/>
        </p:nvSpPr>
        <p:spPr>
          <a:xfrm>
            <a:off x="1238059" y="1886893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V5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AE7EB3D-79BB-0F71-B156-21D50EE92E63}"/>
              </a:ext>
            </a:extLst>
          </p:cNvPr>
          <p:cNvSpPr txBox="1"/>
          <p:nvPr/>
        </p:nvSpPr>
        <p:spPr>
          <a:xfrm>
            <a:off x="719968" y="3831888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ABL</a:t>
            </a:r>
          </a:p>
        </p:txBody>
      </p:sp>
      <p:sp>
        <p:nvSpPr>
          <p:cNvPr id="8" name="左中かっこ 7">
            <a:extLst>
              <a:ext uri="{FF2B5EF4-FFF2-40B4-BE49-F238E27FC236}">
                <a16:creationId xmlns:a16="http://schemas.microsoft.com/office/drawing/2014/main" id="{B444BE12-AC08-0E97-CE3C-9224DCB7E900}"/>
              </a:ext>
            </a:extLst>
          </p:cNvPr>
          <p:cNvSpPr/>
          <p:nvPr/>
        </p:nvSpPr>
        <p:spPr>
          <a:xfrm>
            <a:off x="1306800" y="3837165"/>
            <a:ext cx="158400" cy="369332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058CFA0-32F2-B3DF-6BFA-1768CD4A721E}"/>
              </a:ext>
            </a:extLst>
          </p:cNvPr>
          <p:cNvSpPr txBox="1"/>
          <p:nvPr/>
        </p:nvSpPr>
        <p:spPr>
          <a:xfrm>
            <a:off x="1378800" y="364052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d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242B4AA-D280-7275-D797-5C1973E344E6}"/>
              </a:ext>
            </a:extLst>
          </p:cNvPr>
          <p:cNvSpPr txBox="1"/>
          <p:nvPr/>
        </p:nvSpPr>
        <p:spPr>
          <a:xfrm>
            <a:off x="1378800" y="400112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p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98FD0F2-A39E-B494-01AE-E2F7FECBF178}"/>
              </a:ext>
            </a:extLst>
          </p:cNvPr>
          <p:cNvSpPr txBox="1"/>
          <p:nvPr/>
        </p:nvSpPr>
        <p:spPr>
          <a:xfrm>
            <a:off x="854458" y="2725787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RA</a:t>
            </a:r>
          </a:p>
        </p:txBody>
      </p:sp>
      <p:sp>
        <p:nvSpPr>
          <p:cNvPr id="13" name="左中かっこ 12">
            <a:extLst>
              <a:ext uri="{FF2B5EF4-FFF2-40B4-BE49-F238E27FC236}">
                <a16:creationId xmlns:a16="http://schemas.microsoft.com/office/drawing/2014/main" id="{0040CDF1-D510-9259-AAF3-EA680C1FF6DC}"/>
              </a:ext>
            </a:extLst>
          </p:cNvPr>
          <p:cNvSpPr/>
          <p:nvPr/>
        </p:nvSpPr>
        <p:spPr>
          <a:xfrm>
            <a:off x="1305150" y="2364436"/>
            <a:ext cx="158400" cy="1107399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16E3A50-3663-E939-C761-2CFBB1726D37}"/>
              </a:ext>
            </a:extLst>
          </p:cNvPr>
          <p:cNvSpPr txBox="1"/>
          <p:nvPr/>
        </p:nvSpPr>
        <p:spPr>
          <a:xfrm>
            <a:off x="1378800" y="219152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d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A86AD82-21B1-9406-BED0-6A0F18E5823E}"/>
              </a:ext>
            </a:extLst>
          </p:cNvPr>
          <p:cNvSpPr txBox="1"/>
          <p:nvPr/>
        </p:nvSpPr>
        <p:spPr>
          <a:xfrm>
            <a:off x="1378800" y="324527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p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6" name="左中かっこ 15">
            <a:extLst>
              <a:ext uri="{FF2B5EF4-FFF2-40B4-BE49-F238E27FC236}">
                <a16:creationId xmlns:a16="http://schemas.microsoft.com/office/drawing/2014/main" id="{F36E497A-680A-CB6B-42E3-CBB185DA525A}"/>
              </a:ext>
            </a:extLst>
          </p:cNvPr>
          <p:cNvSpPr/>
          <p:nvPr/>
        </p:nvSpPr>
        <p:spPr>
          <a:xfrm>
            <a:off x="1306800" y="4559221"/>
            <a:ext cx="158400" cy="1471466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>
              <a:latin typeface="+mj-ea"/>
              <a:ea typeface="+mj-ea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0B5E94A-EB46-0C19-FE3E-FFFAA4B4C6BB}"/>
              </a:ext>
            </a:extLst>
          </p:cNvPr>
          <p:cNvSpPr txBox="1"/>
          <p:nvPr/>
        </p:nvSpPr>
        <p:spPr>
          <a:xfrm>
            <a:off x="1378800" y="437455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d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675624A-B11D-01AC-F1FD-0AA94C2F5E46}"/>
              </a:ext>
            </a:extLst>
          </p:cNvPr>
          <p:cNvSpPr txBox="1"/>
          <p:nvPr/>
        </p:nvSpPr>
        <p:spPr>
          <a:xfrm>
            <a:off x="1378800" y="581514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ea"/>
                <a:ea typeface="+mj-ea"/>
              </a:rPr>
              <a:t>p</a:t>
            </a:r>
            <a:endParaRPr kumimoji="1" lang="ja-JP" altLang="en-US" b="1" dirty="0">
              <a:latin typeface="+mj-ea"/>
              <a:ea typeface="+mj-ea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648FF05-5078-02D5-45DD-2F08C3A6D80B}"/>
              </a:ext>
            </a:extLst>
          </p:cNvPr>
          <p:cNvSpPr txBox="1"/>
          <p:nvPr/>
        </p:nvSpPr>
        <p:spPr>
          <a:xfrm>
            <a:off x="867282" y="5110288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+mj-ea"/>
                <a:ea typeface="+mj-ea"/>
              </a:rPr>
              <a:t>CS</a:t>
            </a:r>
          </a:p>
        </p:txBody>
      </p:sp>
    </p:spTree>
    <p:extLst>
      <p:ext uri="{BB962C8B-B14F-4D97-AF65-F5344CB8AC3E}">
        <p14:creationId xmlns:p14="http://schemas.microsoft.com/office/powerpoint/2010/main" val="11816699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446B27-B96F-C0D4-9B6E-757C11FD9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78433"/>
            <a:ext cx="2386263" cy="304800"/>
          </a:xfrm>
        </p:spPr>
        <p:txBody>
          <a:bodyPr>
            <a:noAutofit/>
          </a:bodyPr>
          <a:lstStyle/>
          <a:p>
            <a:r>
              <a:rPr kumimoji="1" lang="en-US" altLang="ja-JP" sz="1600" b="1" dirty="0">
                <a:solidFill>
                  <a:schemeClr val="bg1"/>
                </a:solidFill>
              </a:rPr>
              <a:t>Figure S7</a:t>
            </a:r>
            <a:endParaRPr kumimoji="1" lang="ja-JP" altLang="en-US" sz="1600" b="1" dirty="0">
              <a:solidFill>
                <a:schemeClr val="bg1"/>
              </a:solidFill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03E9E37-6070-8C49-852F-EC22A00F83CA}"/>
              </a:ext>
            </a:extLst>
          </p:cNvPr>
          <p:cNvSpPr txBox="1"/>
          <p:nvPr/>
        </p:nvSpPr>
        <p:spPr>
          <a:xfrm>
            <a:off x="2855495" y="304800"/>
            <a:ext cx="17806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solidFill>
                  <a:schemeClr val="bg1"/>
                </a:solidFill>
              </a:rPr>
              <a:t>Pre</a:t>
            </a:r>
            <a:endParaRPr kumimoji="1" lang="ja-JP" altLang="en-US" sz="2400" b="1" dirty="0">
              <a:solidFill>
                <a:schemeClr val="bg1"/>
              </a:solidFill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DDAF772-7D95-146C-B296-1BD9A9BCC92B}"/>
              </a:ext>
            </a:extLst>
          </p:cNvPr>
          <p:cNvSpPr txBox="1"/>
          <p:nvPr/>
        </p:nvSpPr>
        <p:spPr>
          <a:xfrm>
            <a:off x="7820546" y="304801"/>
            <a:ext cx="17806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solidFill>
                  <a:schemeClr val="bg1"/>
                </a:solidFill>
              </a:rPr>
              <a:t>Post</a:t>
            </a:r>
            <a:endParaRPr kumimoji="1" lang="ja-JP" altLang="en-US" sz="2400" b="1" dirty="0">
              <a:solidFill>
                <a:schemeClr val="bg1"/>
              </a:solidFill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4E4AD66D-127E-CBBC-CC4A-09908485803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0335" y="766465"/>
            <a:ext cx="10147750" cy="58145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6647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Arial"/>
        <a:ea typeface="Arial"/>
        <a:cs typeface=""/>
      </a:majorFont>
      <a:minorFont>
        <a:latin typeface="Arial"/>
        <a:ea typeface="Arial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4</TotalTime>
  <Words>74</Words>
  <Application>Microsoft Office PowerPoint</Application>
  <PresentationFormat>ワイド画面</PresentationFormat>
  <Paragraphs>67</Paragraphs>
  <Slides>7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0" baseType="lpstr">
      <vt:lpstr>游ゴシック</vt:lpstr>
      <vt:lpstr>Arial</vt:lpstr>
      <vt:lpstr>Office テーマ</vt:lpstr>
      <vt:lpstr>Figure S1</vt:lpstr>
      <vt:lpstr>Figure S2</vt:lpstr>
      <vt:lpstr>Figure S3</vt:lpstr>
      <vt:lpstr>Figure S4</vt:lpstr>
      <vt:lpstr>Figure S5</vt:lpstr>
      <vt:lpstr>Figure S6</vt:lpstr>
      <vt:lpstr>Figure S7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1A pre map</dc:title>
  <dc:creator>Taishi Fukushima</dc:creator>
  <cp:lastModifiedBy>Taishi Fukushima</cp:lastModifiedBy>
  <cp:revision>12</cp:revision>
  <dcterms:created xsi:type="dcterms:W3CDTF">2024-12-08T12:44:17Z</dcterms:created>
  <dcterms:modified xsi:type="dcterms:W3CDTF">2025-03-25T04:25:07Z</dcterms:modified>
</cp:coreProperties>
</file>